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9" r:id="rId2"/>
  </p:sldIdLst>
  <p:sldSz cx="6858000" cy="9144000" type="screen4x3"/>
  <p:notesSz cx="6794500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8B9D7920-36D0-404C-A201-213143DFBD09}">
          <p14:sldIdLst>
            <p14:sldId id="289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 Fleischer" initials="MFl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99" autoAdjust="0"/>
    <p:restoredTop sz="94608" autoAdjust="0"/>
  </p:normalViewPr>
  <p:slideViewPr>
    <p:cSldViewPr>
      <p:cViewPr>
        <p:scale>
          <a:sx n="125" d="100"/>
          <a:sy n="125" d="100"/>
        </p:scale>
        <p:origin x="-2352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207B54-3EAD-41A2-9352-A64606E391C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D634A-284F-4D9E-B1D0-2C5BCE8A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641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A88D9-F2BA-41FC-9080-83DF67410D2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749300"/>
            <a:ext cx="28067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BE942-E908-4AA3-ACE1-A14A84257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02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993900" y="749300"/>
            <a:ext cx="2806700" cy="37433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2BE942-E908-4AA3-ACE1-A14A842573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835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5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3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63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2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93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9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6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8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5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tiff"/><Relationship Id="rId18" Type="http://schemas.openxmlformats.org/officeDocument/2006/relationships/image" Target="../media/image14.tiff"/><Relationship Id="rId3" Type="http://schemas.openxmlformats.org/officeDocument/2006/relationships/image" Target="../media/image1.tiff"/><Relationship Id="rId21" Type="http://schemas.openxmlformats.org/officeDocument/2006/relationships/image" Target="../media/image17.tiff"/><Relationship Id="rId7" Type="http://schemas.openxmlformats.org/officeDocument/2006/relationships/image" Target="../media/image4.tiff"/><Relationship Id="rId12" Type="http://schemas.openxmlformats.org/officeDocument/2006/relationships/image" Target="../media/image8.tiff"/><Relationship Id="rId17" Type="http://schemas.openxmlformats.org/officeDocument/2006/relationships/image" Target="../media/image13.tiff"/><Relationship Id="rId25" Type="http://schemas.openxmlformats.org/officeDocument/2006/relationships/image" Target="../media/image21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tiff"/><Relationship Id="rId20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7.tiff"/><Relationship Id="rId24" Type="http://schemas.openxmlformats.org/officeDocument/2006/relationships/image" Target="../media/image20.png"/><Relationship Id="rId5" Type="http://schemas.openxmlformats.org/officeDocument/2006/relationships/image" Target="../media/image3.png"/><Relationship Id="rId15" Type="http://schemas.openxmlformats.org/officeDocument/2006/relationships/image" Target="../media/image11.tiff"/><Relationship Id="rId23" Type="http://schemas.openxmlformats.org/officeDocument/2006/relationships/image" Target="../media/image19.png"/><Relationship Id="rId10" Type="http://schemas.openxmlformats.org/officeDocument/2006/relationships/image" Target="../media/image6.tiff"/><Relationship Id="rId19" Type="http://schemas.openxmlformats.org/officeDocument/2006/relationships/image" Target="../media/image15.tiff"/><Relationship Id="rId4" Type="http://schemas.openxmlformats.org/officeDocument/2006/relationships/image" Target="../media/image2.tiff"/><Relationship Id="rId9" Type="http://schemas.microsoft.com/office/2007/relationships/hdphoto" Target="../media/hdphoto2.wdp"/><Relationship Id="rId14" Type="http://schemas.openxmlformats.org/officeDocument/2006/relationships/image" Target="../media/image10.tiff"/><Relationship Id="rId22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5773" y="1784722"/>
            <a:ext cx="19483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2033888" y="1691680"/>
            <a:ext cx="4821079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chez-Mendoza, et al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feron-α and TLR3 activation-induced depression associated with compromised hippocampal plasticity</a:t>
            </a:r>
          </a:p>
        </p:txBody>
      </p:sp>
      <p:grpSp>
        <p:nvGrpSpPr>
          <p:cNvPr id="21" name="Gruppieren 20"/>
          <p:cNvGrpSpPr/>
          <p:nvPr/>
        </p:nvGrpSpPr>
        <p:grpSpPr>
          <a:xfrm>
            <a:off x="-50048" y="2559398"/>
            <a:ext cx="6821593" cy="5023221"/>
            <a:chOff x="-50048" y="2559398"/>
            <a:chExt cx="6821593" cy="5023221"/>
          </a:xfrm>
        </p:grpSpPr>
        <p:grpSp>
          <p:nvGrpSpPr>
            <p:cNvPr id="18" name="Gruppieren 17"/>
            <p:cNvGrpSpPr/>
            <p:nvPr/>
          </p:nvGrpSpPr>
          <p:grpSpPr>
            <a:xfrm>
              <a:off x="944724" y="2559398"/>
              <a:ext cx="4838685" cy="2936532"/>
              <a:chOff x="1259632" y="161698"/>
              <a:chExt cx="6451580" cy="3915374"/>
            </a:xfrm>
          </p:grpSpPr>
          <p:sp>
            <p:nvSpPr>
              <p:cNvPr id="67" name="Textfeld 66"/>
              <p:cNvSpPr txBox="1"/>
              <p:nvPr/>
            </p:nvSpPr>
            <p:spPr>
              <a:xfrm>
                <a:off x="1259632" y="185634"/>
                <a:ext cx="472483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)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6" name="Gruppieren 15"/>
              <p:cNvGrpSpPr/>
              <p:nvPr/>
            </p:nvGrpSpPr>
            <p:grpSpPr>
              <a:xfrm>
                <a:off x="1732115" y="656197"/>
                <a:ext cx="1437734" cy="3202304"/>
                <a:chOff x="180822" y="656197"/>
                <a:chExt cx="1240692" cy="2983765"/>
              </a:xfrm>
            </p:grpSpPr>
            <p:grpSp>
              <p:nvGrpSpPr>
                <p:cNvPr id="13" name="Gruppieren 12"/>
                <p:cNvGrpSpPr/>
                <p:nvPr/>
              </p:nvGrpSpPr>
              <p:grpSpPr>
                <a:xfrm>
                  <a:off x="180822" y="656197"/>
                  <a:ext cx="1240692" cy="2983765"/>
                  <a:chOff x="162956" y="660905"/>
                  <a:chExt cx="1440160" cy="4013504"/>
                </a:xfrm>
              </p:grpSpPr>
              <p:pic>
                <p:nvPicPr>
                  <p:cNvPr id="3099" name="Picture 27" descr="F:\Poly IC project\Sofyen NF MBP\Hippocampus\G11\MBP NF merge.tif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62956" y="660905"/>
                    <a:ext cx="1440160" cy="401350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cxnSp>
                <p:nvCxnSpPr>
                  <p:cNvPr id="54" name="Gerade Verbindung 53"/>
                  <p:cNvCxnSpPr/>
                  <p:nvPr/>
                </p:nvCxnSpPr>
                <p:spPr>
                  <a:xfrm>
                    <a:off x="1172908" y="4523474"/>
                    <a:ext cx="343344" cy="0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2" name="Gruppieren 11"/>
                <p:cNvGrpSpPr/>
                <p:nvPr/>
              </p:nvGrpSpPr>
              <p:grpSpPr>
                <a:xfrm>
                  <a:off x="838690" y="1866451"/>
                  <a:ext cx="504056" cy="323985"/>
                  <a:chOff x="1011057" y="2335811"/>
                  <a:chExt cx="504056" cy="323985"/>
                </a:xfrm>
              </p:grpSpPr>
              <p:sp>
                <p:nvSpPr>
                  <p:cNvPr id="56" name="Rechteck 55"/>
                  <p:cNvSpPr/>
                  <p:nvPr/>
                </p:nvSpPr>
                <p:spPr>
                  <a:xfrm>
                    <a:off x="1011057" y="2335811"/>
                    <a:ext cx="504056" cy="323985"/>
                  </a:xfrm>
                  <a:prstGeom prst="rect">
                    <a:avLst/>
                  </a:prstGeom>
                  <a:noFill/>
                  <a:ln w="6350">
                    <a:solidFill>
                      <a:srgbClr val="FFFF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1" name="Textfeld 70"/>
                  <p:cNvSpPr txBox="1"/>
                  <p:nvPr/>
                </p:nvSpPr>
                <p:spPr>
                  <a:xfrm>
                    <a:off x="1026844" y="2390081"/>
                    <a:ext cx="472484" cy="22941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600" b="1" dirty="0" err="1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m</a:t>
                    </a:r>
                    <a:endParaRPr lang="en-US" sz="60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" name="Gruppieren 9"/>
                <p:cNvGrpSpPr/>
                <p:nvPr/>
              </p:nvGrpSpPr>
              <p:grpSpPr>
                <a:xfrm>
                  <a:off x="829743" y="2964398"/>
                  <a:ext cx="504056" cy="323985"/>
                  <a:chOff x="992585" y="3876670"/>
                  <a:chExt cx="504056" cy="323985"/>
                </a:xfrm>
              </p:grpSpPr>
              <p:sp>
                <p:nvSpPr>
                  <p:cNvPr id="55" name="Rechteck 54"/>
                  <p:cNvSpPr/>
                  <p:nvPr/>
                </p:nvSpPr>
                <p:spPr>
                  <a:xfrm>
                    <a:off x="992585" y="3876670"/>
                    <a:ext cx="504056" cy="323985"/>
                  </a:xfrm>
                  <a:prstGeom prst="rect">
                    <a:avLst/>
                  </a:prstGeom>
                  <a:noFill/>
                  <a:ln w="6350">
                    <a:solidFill>
                      <a:srgbClr val="FFFF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2" name="Textfeld 71"/>
                  <p:cNvSpPr txBox="1"/>
                  <p:nvPr/>
                </p:nvSpPr>
                <p:spPr>
                  <a:xfrm>
                    <a:off x="1008372" y="3930940"/>
                    <a:ext cx="472484" cy="22941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600" b="1" dirty="0" err="1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</a:t>
                    </a:r>
                    <a:endParaRPr lang="en-US" sz="60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19" name="Textfeld 18"/>
              <p:cNvSpPr txBox="1"/>
              <p:nvPr/>
            </p:nvSpPr>
            <p:spPr>
              <a:xfrm>
                <a:off x="3820347" y="567324"/>
                <a:ext cx="444480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F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feld 19"/>
              <p:cNvSpPr txBox="1"/>
              <p:nvPr/>
            </p:nvSpPr>
            <p:spPr>
              <a:xfrm>
                <a:off x="4833452" y="567325"/>
                <a:ext cx="568625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BP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feld 22"/>
              <p:cNvSpPr txBox="1"/>
              <p:nvPr/>
            </p:nvSpPr>
            <p:spPr>
              <a:xfrm>
                <a:off x="4264827" y="266585"/>
                <a:ext cx="568625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1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feld 23"/>
              <p:cNvSpPr txBox="1"/>
              <p:nvPr/>
            </p:nvSpPr>
            <p:spPr>
              <a:xfrm>
                <a:off x="6368021" y="266583"/>
                <a:ext cx="568625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G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feld 24"/>
              <p:cNvSpPr txBox="1"/>
              <p:nvPr/>
            </p:nvSpPr>
            <p:spPr>
              <a:xfrm rot="16200000">
                <a:off x="3048343" y="1061887"/>
                <a:ext cx="712641" cy="2616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feld 27"/>
              <p:cNvSpPr txBox="1"/>
              <p:nvPr/>
            </p:nvSpPr>
            <p:spPr>
              <a:xfrm rot="16200000">
                <a:off x="3048343" y="1789746"/>
                <a:ext cx="712641" cy="2616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de-DE" sz="675" b="1" dirty="0">
                    <a:latin typeface="Symbol" panose="05050102010706020507" pitchFamily="18" charset="2"/>
                    <a:cs typeface="Times New Roman" panose="02020603050405020304" pitchFamily="18" charset="0"/>
                  </a:rPr>
                  <a:t>a</a:t>
                </a:r>
                <a:endParaRPr lang="en-US" sz="675" b="1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feld 28"/>
              <p:cNvSpPr txBox="1"/>
              <p:nvPr/>
            </p:nvSpPr>
            <p:spPr>
              <a:xfrm rot="16200000">
                <a:off x="2920503" y="2558220"/>
                <a:ext cx="968320" cy="2616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75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</a:t>
                </a:r>
                <a:r>
                  <a:rPr lang="de-DE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I:C)</a:t>
                </a:r>
                <a:endParaRPr 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 rot="16200000">
                <a:off x="2858713" y="3208716"/>
                <a:ext cx="1198102" cy="5386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de-DE" sz="675" b="1" dirty="0">
                    <a:latin typeface="Symbol" panose="05050102010706020507" pitchFamily="18" charset="2"/>
                    <a:cs typeface="Times New Roman" panose="02020603050405020304" pitchFamily="18" charset="0"/>
                  </a:rPr>
                  <a:t>a/</a:t>
                </a:r>
              </a:p>
              <a:p>
                <a:pPr algn="ctr"/>
                <a:r>
                  <a:rPr lang="de-DE" sz="675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</a:t>
                </a:r>
                <a:r>
                  <a:rPr lang="de-DE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I:C)</a:t>
                </a:r>
                <a:endParaRPr 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675" b="1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7" name="Gerade Verbindung 16"/>
              <p:cNvCxnSpPr>
                <a:stCxn id="19" idx="0"/>
                <a:endCxn id="20" idx="0"/>
              </p:cNvCxnSpPr>
              <p:nvPr/>
            </p:nvCxnSpPr>
            <p:spPr>
              <a:xfrm>
                <a:off x="4042587" y="567324"/>
                <a:ext cx="107517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feld 63"/>
              <p:cNvSpPr txBox="1"/>
              <p:nvPr/>
            </p:nvSpPr>
            <p:spPr>
              <a:xfrm>
                <a:off x="5911025" y="563092"/>
                <a:ext cx="444480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F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Textfeld 64"/>
              <p:cNvSpPr txBox="1"/>
              <p:nvPr/>
            </p:nvSpPr>
            <p:spPr>
              <a:xfrm>
                <a:off x="6924131" y="563093"/>
                <a:ext cx="568625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BP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6" name="Gerade Verbindung 65"/>
              <p:cNvCxnSpPr>
                <a:stCxn id="64" idx="0"/>
                <a:endCxn id="65" idx="0"/>
              </p:cNvCxnSpPr>
              <p:nvPr/>
            </p:nvCxnSpPr>
            <p:spPr>
              <a:xfrm>
                <a:off x="6133265" y="563092"/>
                <a:ext cx="107517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feld 67"/>
              <p:cNvSpPr txBox="1"/>
              <p:nvPr/>
            </p:nvSpPr>
            <p:spPr>
              <a:xfrm>
                <a:off x="3169849" y="161698"/>
                <a:ext cx="472483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9" name="Gruppieren 8"/>
              <p:cNvGrpSpPr/>
              <p:nvPr/>
            </p:nvGrpSpPr>
            <p:grpSpPr>
              <a:xfrm>
                <a:off x="3568141" y="844940"/>
                <a:ext cx="4143071" cy="3016108"/>
                <a:chOff x="1985963" y="996733"/>
                <a:chExt cx="4902453" cy="3679286"/>
              </a:xfrm>
            </p:grpSpPr>
            <p:pic>
              <p:nvPicPr>
                <p:cNvPr id="4113" name="Picture 17" descr="F:\Poly IC project\Sofyen NF MBP\Hippocampus\Images paper\CA1\Paper check\DG\Costimulation.tif (red) MBP.tif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707380" y="3800475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098" name="Picture 2" descr="F:\Poly IC project\Sofyen NF MBP\Hippocampus\Images paper\CA1\Paper check\CA1 MBP control.tif"/>
                <p:cNvPicPr preferRelativeResize="0">
                  <a:picLocks noChangeArrowheads="1"/>
                </p:cNvPicPr>
                <p:nvPr/>
              </p:nvPicPr>
              <p:blipFill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19991" y="1006128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099" name="Picture 3" descr="F:\Poly IC project\Sofyen NF MBP\Hippocampus\Images paper\CA1\Paper check\CA1 NF control.tif"/>
                <p:cNvPicPr preferRelativeResize="0">
                  <a:picLocks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985963" y="1009650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0" name="Picture 4" descr="F:\Poly IC project\Sofyen NF MBP\Hippocampus\Images paper\CA1\Paper check\DG MBP control.tif"/>
                <p:cNvPicPr preferRelativeResize="0">
                  <a:picLocks noChangeArrowheads="1"/>
                </p:cNvPicPr>
                <p:nvPr/>
              </p:nvPicPr>
              <p:blipFill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714816" y="996733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1" name="Picture 5" descr="F:\Poly IC project\Sofyen NF MBP\Hippocampus\Images paper\CA1\Paper check\DG NF control.tif"/>
                <p:cNvPicPr preferRelativeResize="0">
                  <a:picLocks noChangeArrowheads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471572" y="998463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3" name="Picture 7" descr="F:\Poly IC project\Sofyen NF MBP\Hippocampus\Images paper\CA1\Paper check\CA1 NF IFN.tif"/>
                <p:cNvPicPr preferRelativeResize="0">
                  <a:picLocks noChangeArrowheads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988123" y="1930169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4" name="Picture 8" descr="F:\Poly IC project\Sofyen NF MBP\Hippocampus\Images paper\CA1\Paper check\CA1 MBP IFN.tif"/>
                <p:cNvPicPr preferRelativeResize="0">
                  <a:picLocks noChangeArrowheads="1"/>
                </p:cNvPicPr>
                <p:nvPr/>
              </p:nvPicPr>
              <p:blipFill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16225" y="1929148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5" name="Picture 9" descr="F:\Poly IC project\Sofyen NF MBP\Hippocampus\Images paper\CA1\Paper check\CA1 Poly IC MBP.tif"/>
                <p:cNvPicPr preferRelativeResize="0">
                  <a:picLocks noChangeArrowheads="1"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16225" y="2869748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6" name="Picture 10" descr="F:\Poly IC project\Sofyen NF MBP\Hippocampus\Images paper\CA1\Paper check\CA1 Poly IC NF.tif"/>
                <p:cNvPicPr preferRelativeResize="0">
                  <a:picLocks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988123" y="2869735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7" name="Picture 11" descr="F:\Poly IC project\Sofyen NF MBP\Hippocampus\Images paper\CA1\Paper check\CA1 costimulation NF.tif"/>
                <p:cNvPicPr preferRelativeResize="0">
                  <a:picLocks noChangeArrowheads="1"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986707" y="3798112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8" name="Picture 12" descr="F:\Poly IC project\Sofyen NF MBP\Hippocampus\Images paper\CA1\Paper check\CA1 MBP  costimulation NF.tif"/>
                <p:cNvPicPr preferRelativeResize="0">
                  <a:picLocks noChangeArrowheads="1"/>
                </p:cNvPicPr>
                <p:nvPr/>
              </p:nvPicPr>
              <p:blipFill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15897" y="3801219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09" name="Picture 13" descr="F:\Poly IC project\Sofyen NF MBP\Hippocampus\Images paper\CA1\Paper check\DG\IFN MBP.tif"/>
                <p:cNvPicPr preferRelativeResize="0">
                  <a:picLocks noChangeArrowheads="1"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710903" y="1925860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10" name="Picture 14" descr="F:\Poly IC project\Sofyen NF MBP\Hippocampus\Images paper\CA1\Paper check\DG\IFN NF.tif"/>
                <p:cNvPicPr preferRelativeResize="0">
                  <a:picLocks noChangeArrowheads="1"/>
                </p:cNvPicPr>
                <p:nvPr/>
              </p:nvPicPr>
              <p:blipFill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471572" y="1922688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11" name="Picture 15" descr="F:\Poly IC project\Sofyen NF MBP\Hippocampus\Images paper\CA1\Paper check\DG\Poly IC.tif (green) NF.tif"/>
                <p:cNvPicPr preferRelativeResize="0">
                  <a:picLocks noChangeArrowheads="1"/>
                </p:cNvPicPr>
                <p:nvPr/>
              </p:nvPicPr>
              <p:blipFill>
                <a:blip r:embed="rId1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466161" y="2866584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12" name="Picture 16" descr="F:\Poly IC project\Sofyen NF MBP\Hippocampus\Images paper\CA1\Paper check\DG\Poly IC.tif (red) MBP.tif"/>
                <p:cNvPicPr preferRelativeResize="0">
                  <a:picLocks noChangeArrowheads="1"/>
                </p:cNvPicPr>
                <p:nvPr/>
              </p:nvPicPr>
              <p:blipFill>
                <a:blip r:embed="rId2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713521" y="2866584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14" name="Picture 18" descr="F:\Poly IC project\Sofyen NF MBP\Hippocampus\Images paper\CA1\Paper check\DG\Costimulation.tif (green) NF.tif"/>
                <p:cNvPicPr preferRelativeResize="0">
                  <a:picLocks noChangeArrowheads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463637" y="3799813"/>
                  <a:ext cx="1173600" cy="874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</p:grpSp>
        <p:grpSp>
          <p:nvGrpSpPr>
            <p:cNvPr id="31" name="Gruppieren 30"/>
            <p:cNvGrpSpPr/>
            <p:nvPr/>
          </p:nvGrpSpPr>
          <p:grpSpPr>
            <a:xfrm>
              <a:off x="390526" y="5805322"/>
              <a:ext cx="6113930" cy="1777297"/>
              <a:chOff x="520702" y="3736814"/>
              <a:chExt cx="8151906" cy="2369728"/>
            </a:xfrm>
          </p:grpSpPr>
          <p:cxnSp>
            <p:nvCxnSpPr>
              <p:cNvPr id="11" name="Gerade Verbindung 10"/>
              <p:cNvCxnSpPr/>
              <p:nvPr/>
            </p:nvCxnSpPr>
            <p:spPr>
              <a:xfrm>
                <a:off x="6465717" y="4625686"/>
                <a:ext cx="34334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feld 60"/>
              <p:cNvSpPr txBox="1"/>
              <p:nvPr/>
            </p:nvSpPr>
            <p:spPr>
              <a:xfrm>
                <a:off x="7448472" y="3776370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G MBP</a:t>
                </a:r>
                <a:endParaRPr lang="en-US" sz="7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Textfeld 97"/>
              <p:cNvSpPr txBox="1"/>
              <p:nvPr/>
            </p:nvSpPr>
            <p:spPr>
              <a:xfrm>
                <a:off x="5014024" y="3738942"/>
                <a:ext cx="163830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G NF</a:t>
                </a:r>
                <a:endParaRPr lang="en-US" sz="7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7" name="Gruppieren 26"/>
              <p:cNvGrpSpPr/>
              <p:nvPr/>
            </p:nvGrpSpPr>
            <p:grpSpPr>
              <a:xfrm>
                <a:off x="520702" y="3773178"/>
                <a:ext cx="1848992" cy="2333364"/>
                <a:chOff x="520702" y="3773178"/>
                <a:chExt cx="1848992" cy="2333364"/>
              </a:xfrm>
            </p:grpSpPr>
            <p:sp>
              <p:nvSpPr>
                <p:cNvPr id="109" name="Textfeld 108"/>
                <p:cNvSpPr txBox="1"/>
                <p:nvPr/>
              </p:nvSpPr>
              <p:spPr>
                <a:xfrm>
                  <a:off x="605547" y="3773178"/>
                  <a:ext cx="1638311" cy="2769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7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1 NF</a:t>
                  </a:r>
                  <a:endParaRPr lang="en-US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10" name="Gruppieren 109"/>
                <p:cNvGrpSpPr/>
                <p:nvPr/>
              </p:nvGrpSpPr>
              <p:grpSpPr>
                <a:xfrm>
                  <a:off x="520702" y="5737210"/>
                  <a:ext cx="1848992" cy="369332"/>
                  <a:chOff x="6796576" y="2894957"/>
                  <a:chExt cx="1758826" cy="369332"/>
                </a:xfrm>
                <a:noFill/>
              </p:grpSpPr>
              <p:sp>
                <p:nvSpPr>
                  <p:cNvPr id="111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207318" y="2911604"/>
                    <a:ext cx="491981" cy="246223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2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938932" y="2894957"/>
                    <a:ext cx="616470" cy="36933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/</a:t>
                    </a:r>
                  </a:p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3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13361" y="2911604"/>
                    <a:ext cx="624471" cy="246223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4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796576" y="2903521"/>
                    <a:ext cx="546247" cy="246223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125" name="Textfeld 124"/>
              <p:cNvSpPr txBox="1"/>
              <p:nvPr/>
            </p:nvSpPr>
            <p:spPr>
              <a:xfrm>
                <a:off x="2772106" y="3736814"/>
                <a:ext cx="163830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1 MBP</a:t>
                </a:r>
                <a:endParaRPr lang="en-US" sz="7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8" name="Textfeld 127"/>
            <p:cNvSpPr txBox="1"/>
            <p:nvPr/>
          </p:nvSpPr>
          <p:spPr>
            <a:xfrm>
              <a:off x="-50048" y="5670701"/>
              <a:ext cx="354362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2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  <a:endParaRPr lang="en-US" sz="82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Textfeld 128"/>
            <p:cNvSpPr txBox="1"/>
            <p:nvPr/>
          </p:nvSpPr>
          <p:spPr>
            <a:xfrm>
              <a:off x="1599517" y="5678945"/>
              <a:ext cx="354362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2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</a:t>
              </a:r>
              <a:endParaRPr lang="en-US" sz="82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feld 129"/>
            <p:cNvSpPr txBox="1"/>
            <p:nvPr/>
          </p:nvSpPr>
          <p:spPr>
            <a:xfrm>
              <a:off x="3347526" y="5689905"/>
              <a:ext cx="354362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2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)</a:t>
              </a:r>
              <a:endParaRPr lang="en-US" sz="82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extfeld 130"/>
            <p:cNvSpPr txBox="1"/>
            <p:nvPr/>
          </p:nvSpPr>
          <p:spPr>
            <a:xfrm>
              <a:off x="4950715" y="5709920"/>
              <a:ext cx="354362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2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)</a:t>
              </a:r>
              <a:endParaRPr lang="en-US" sz="82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6" name="Gerade Verbindung 135"/>
            <p:cNvCxnSpPr/>
            <p:nvPr/>
          </p:nvCxnSpPr>
          <p:spPr>
            <a:xfrm>
              <a:off x="5586354" y="5712650"/>
              <a:ext cx="144563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Gruppieren 7"/>
            <p:cNvGrpSpPr/>
            <p:nvPr/>
          </p:nvGrpSpPr>
          <p:grpSpPr>
            <a:xfrm>
              <a:off x="70219" y="6034836"/>
              <a:ext cx="6568180" cy="1281147"/>
              <a:chOff x="93626" y="4765204"/>
              <a:chExt cx="8757573" cy="1708195"/>
            </a:xfrm>
          </p:grpSpPr>
          <p:pic>
            <p:nvPicPr>
              <p:cNvPr id="3" name="Grafik 2"/>
              <p:cNvPicPr preferRelativeResize="0">
                <a:picLocks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93626" y="4781400"/>
                <a:ext cx="2152800" cy="1691999"/>
              </a:xfrm>
              <a:prstGeom prst="rect">
                <a:avLst/>
              </a:prstGeom>
            </p:spPr>
          </p:pic>
          <p:pic>
            <p:nvPicPr>
              <p:cNvPr id="5" name="Grafik 4"/>
              <p:cNvPicPr preferRelativeResize="0">
                <a:picLocks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4545599" y="4770758"/>
                <a:ext cx="2152800" cy="1692000"/>
              </a:xfrm>
              <a:prstGeom prst="rect">
                <a:avLst/>
              </a:prstGeom>
            </p:spPr>
          </p:pic>
          <p:pic>
            <p:nvPicPr>
              <p:cNvPr id="6" name="Grafik 5"/>
              <p:cNvPicPr preferRelativeResize="0">
                <a:picLocks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2342636" y="4774776"/>
                <a:ext cx="2152800" cy="1692000"/>
              </a:xfrm>
              <a:prstGeom prst="rect">
                <a:avLst/>
              </a:prstGeom>
            </p:spPr>
          </p:pic>
          <p:pic>
            <p:nvPicPr>
              <p:cNvPr id="7" name="Grafik 6"/>
              <p:cNvPicPr preferRelativeResize="0">
                <a:picLocks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6698399" y="4765204"/>
                <a:ext cx="2152800" cy="1692000"/>
              </a:xfrm>
              <a:prstGeom prst="rect">
                <a:avLst/>
              </a:prstGeom>
            </p:spPr>
          </p:pic>
        </p:grpSp>
        <p:sp>
          <p:nvSpPr>
            <p:cNvPr id="88" name="9 CuadroTexto"/>
            <p:cNvSpPr txBox="1">
              <a:spLocks noChangeArrowheads="1"/>
            </p:cNvSpPr>
            <p:nvPr/>
          </p:nvSpPr>
          <p:spPr bwMode="auto">
            <a:xfrm>
              <a:off x="2438400" y="7299926"/>
              <a:ext cx="387902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6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89" name="9 CuadroTexto"/>
            <p:cNvSpPr txBox="1">
              <a:spLocks noChangeArrowheads="1"/>
            </p:cNvSpPr>
            <p:nvPr/>
          </p:nvSpPr>
          <p:spPr bwMode="auto">
            <a:xfrm>
              <a:off x="3015240" y="7287441"/>
              <a:ext cx="48605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6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/</a:t>
              </a:r>
            </a:p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0" name="9 CuadroTexto"/>
            <p:cNvSpPr txBox="1">
              <a:spLocks noChangeArrowheads="1"/>
            </p:cNvSpPr>
            <p:nvPr/>
          </p:nvSpPr>
          <p:spPr bwMode="auto">
            <a:xfrm>
              <a:off x="2679699" y="7299926"/>
              <a:ext cx="492363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1" name="9 CuadroTexto"/>
            <p:cNvSpPr txBox="1">
              <a:spLocks noChangeArrowheads="1"/>
            </p:cNvSpPr>
            <p:nvPr/>
          </p:nvSpPr>
          <p:spPr bwMode="auto">
            <a:xfrm>
              <a:off x="2114551" y="7293864"/>
              <a:ext cx="430688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2" name="9 CuadroTexto"/>
            <p:cNvSpPr txBox="1">
              <a:spLocks noChangeArrowheads="1"/>
            </p:cNvSpPr>
            <p:nvPr/>
          </p:nvSpPr>
          <p:spPr bwMode="auto">
            <a:xfrm>
              <a:off x="4121150" y="7306276"/>
              <a:ext cx="387902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6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3" name="9 CuadroTexto"/>
            <p:cNvSpPr txBox="1">
              <a:spLocks noChangeArrowheads="1"/>
            </p:cNvSpPr>
            <p:nvPr/>
          </p:nvSpPr>
          <p:spPr bwMode="auto">
            <a:xfrm>
              <a:off x="4697990" y="7293791"/>
              <a:ext cx="48605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6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/</a:t>
              </a:r>
            </a:p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4" name="9 CuadroTexto"/>
            <p:cNvSpPr txBox="1">
              <a:spLocks noChangeArrowheads="1"/>
            </p:cNvSpPr>
            <p:nvPr/>
          </p:nvSpPr>
          <p:spPr bwMode="auto">
            <a:xfrm>
              <a:off x="4362449" y="7306276"/>
              <a:ext cx="492363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5" name="9 CuadroTexto"/>
            <p:cNvSpPr txBox="1">
              <a:spLocks noChangeArrowheads="1"/>
            </p:cNvSpPr>
            <p:nvPr/>
          </p:nvSpPr>
          <p:spPr bwMode="auto">
            <a:xfrm>
              <a:off x="3797301" y="7300214"/>
              <a:ext cx="430688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6" name="9 CuadroTexto"/>
            <p:cNvSpPr txBox="1">
              <a:spLocks noChangeArrowheads="1"/>
            </p:cNvSpPr>
            <p:nvPr/>
          </p:nvSpPr>
          <p:spPr bwMode="auto">
            <a:xfrm>
              <a:off x="5708650" y="7299926"/>
              <a:ext cx="387902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6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7" name="9 CuadroTexto"/>
            <p:cNvSpPr txBox="1">
              <a:spLocks noChangeArrowheads="1"/>
            </p:cNvSpPr>
            <p:nvPr/>
          </p:nvSpPr>
          <p:spPr bwMode="auto">
            <a:xfrm>
              <a:off x="6285490" y="7287441"/>
              <a:ext cx="48605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6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/</a:t>
              </a:r>
            </a:p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9" name="9 CuadroTexto"/>
            <p:cNvSpPr txBox="1">
              <a:spLocks noChangeArrowheads="1"/>
            </p:cNvSpPr>
            <p:nvPr/>
          </p:nvSpPr>
          <p:spPr bwMode="auto">
            <a:xfrm>
              <a:off x="5949949" y="7299926"/>
              <a:ext cx="492363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100" name="9 CuadroTexto"/>
            <p:cNvSpPr txBox="1">
              <a:spLocks noChangeArrowheads="1"/>
            </p:cNvSpPr>
            <p:nvPr/>
          </p:nvSpPr>
          <p:spPr bwMode="auto">
            <a:xfrm>
              <a:off x="5384801" y="7293864"/>
              <a:ext cx="430688" cy="184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endParaRPr lang="en-GB" sz="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70395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7</Words>
  <Application>Microsoft Office PowerPoint</Application>
  <PresentationFormat>On-screen Show (4:3)</PresentationFormat>
  <Paragraphs>4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chez-mendoza, Eduardo</dc:creator>
  <cp:lastModifiedBy>MQUILIOPE</cp:lastModifiedBy>
  <cp:revision>472</cp:revision>
  <cp:lastPrinted>2019-03-06T11:43:59Z</cp:lastPrinted>
  <dcterms:created xsi:type="dcterms:W3CDTF">2018-09-05T14:08:24Z</dcterms:created>
  <dcterms:modified xsi:type="dcterms:W3CDTF">2020-05-22T07:20:17Z</dcterms:modified>
</cp:coreProperties>
</file>